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20.jpeg" ContentType="image/jpeg"/>
  <Override PartName="/ppt/media/image9.png" ContentType="image/png"/>
  <Override PartName="/ppt/media/image13.jpeg" ContentType="image/jpeg"/>
  <Override PartName="/ppt/media/image8.jpeg" ContentType="image/jpeg"/>
  <Override PartName="/ppt/media/image10.jpeg" ContentType="image/jpeg"/>
  <Override PartName="/ppt/media/image7.jpeg" ContentType="image/jpeg"/>
  <Override PartName="/ppt/media/image11.jpeg" ContentType="image/jpeg"/>
  <Override PartName="/ppt/media/image6.jpeg" ContentType="image/jpeg"/>
  <Override PartName="/ppt/media/image5.jpeg" ContentType="image/jpeg"/>
  <Override PartName="/ppt/media/image4.jpeg" ContentType="image/jpeg"/>
  <Override PartName="/ppt/media/image25.jpeg" ContentType="image/jpeg"/>
  <Override PartName="/ppt/media/image21.jpeg" ContentType="image/jpeg"/>
  <Override PartName="/ppt/media/image16.png" ContentType="image/png"/>
  <Override PartName="/ppt/media/image19.png" ContentType="image/png"/>
  <Override PartName="/ppt/media/image18.jpeg" ContentType="image/jpeg"/>
  <Override PartName="/ppt/media/image17.jpeg" ContentType="image/jpeg"/>
  <Override PartName="/ppt/media/image14.jpeg" ContentType="image/jpeg"/>
  <Override PartName="/ppt/media/image22.jpeg" ContentType="image/jpeg"/>
  <Override PartName="/ppt/media/image1.jpeg" ContentType="image/jpeg"/>
  <Override PartName="/ppt/media/image23.jpeg" ContentType="image/jpeg"/>
  <Override PartName="/ppt/media/image2.jpeg" ContentType="image/jpeg"/>
  <Override PartName="/ppt/media/image3.jpeg" ContentType="image/jpeg"/>
  <Override PartName="/ppt/media/image24.jpeg" ContentType="image/jpeg"/>
  <Override PartName="/ppt/media/image1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12E88D-DE27-4F8C-B6A4-6D0AD9AEB2BD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EF27C0-9A3C-4C48-98D9-EFE863FEB513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7DC67E-E976-4BDD-B61F-45A443C217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3B1F1-DC3B-4C3B-B437-85A83169DC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6A7670-9624-4EFF-A36F-B9D4C2992E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08B8D-4D87-4576-80A8-176DD658EF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04A5AC-A493-4763-8AE6-6AC015E0E6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94C2C-DCFC-4F8A-BA64-9E8F99041A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876B4-496B-4E09-AA95-18A494C7ED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DE040F-4239-4EA0-A1DD-D2D6B654A5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38F355-1E98-4662-9C05-8FA172B120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2C111-89C8-4BC9-ACD9-1C6A85AAFF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476873-C4F5-443E-ABBA-B995C1202D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46B246-CEA3-41FA-A49E-F2AF2571E1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B48827-3C5D-4226-8126-E5487CAA0120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pn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pn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slideLayout" Target="../slideLayouts/slideLayout1.xml"/><Relationship Id="rId2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C:\Users\gn912\Desktop\Gabi FOXK2 localization\Gabi 2\Gabi FOXK2 localization\MCF7 0h 3.tif"/>
          <p:cNvPicPr/>
          <p:nvPr/>
        </p:nvPicPr>
        <p:blipFill>
          <a:blip r:embed="rId1"/>
          <a:stretch/>
        </p:blipFill>
        <p:spPr>
          <a:xfrm>
            <a:off x="2360520" y="1216080"/>
            <a:ext cx="973080" cy="9730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" descr="C:\Users\gn912\Desktop\Gabi FOXK2 localization\Gabi 2\Gabi FOXK2 localization\MCF7 0h 3_ch00.tif"/>
          <p:cNvPicPr/>
          <p:nvPr/>
        </p:nvPicPr>
        <p:blipFill>
          <a:blip r:embed="rId2"/>
          <a:stretch/>
        </p:blipFill>
        <p:spPr>
          <a:xfrm>
            <a:off x="1352520" y="1216080"/>
            <a:ext cx="973080" cy="973080"/>
          </a:xfrm>
          <a:prstGeom prst="rect">
            <a:avLst/>
          </a:prstGeom>
          <a:ln w="0">
            <a:noFill/>
          </a:ln>
        </p:spPr>
      </p:pic>
      <p:sp>
        <p:nvSpPr>
          <p:cNvPr id="50" name="TextBox 3"/>
          <p:cNvSpPr/>
          <p:nvPr/>
        </p:nvSpPr>
        <p:spPr>
          <a:xfrm>
            <a:off x="1561680" y="96840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ff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8"/>
          <p:cNvSpPr/>
          <p:nvPr/>
        </p:nvSpPr>
        <p:spPr>
          <a:xfrm>
            <a:off x="2473200" y="968400"/>
            <a:ext cx="63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6" descr="C:\Users\gn912\Desktop\Gabi FOXK2 localization\Gabi 2\Gabi FOXK2 localization\MCF7 0h 3_ch01.tif"/>
          <p:cNvPicPr/>
          <p:nvPr/>
        </p:nvPicPr>
        <p:blipFill>
          <a:blip r:embed="rId3"/>
          <a:stretch/>
        </p:blipFill>
        <p:spPr>
          <a:xfrm>
            <a:off x="371520" y="1212840"/>
            <a:ext cx="963720" cy="976320"/>
          </a:xfrm>
          <a:prstGeom prst="rect">
            <a:avLst/>
          </a:prstGeom>
          <a:ln w="0">
            <a:noFill/>
          </a:ln>
        </p:spPr>
      </p:pic>
      <p:sp>
        <p:nvSpPr>
          <p:cNvPr id="53" name="TextBox 10"/>
          <p:cNvSpPr/>
          <p:nvPr/>
        </p:nvSpPr>
        <p:spPr>
          <a:xfrm>
            <a:off x="529920" y="944640"/>
            <a:ext cx="68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e668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traight Connector 11"/>
          <p:cNvSpPr/>
          <p:nvPr/>
        </p:nvSpPr>
        <p:spPr>
          <a:xfrm>
            <a:off x="298440" y="1432080"/>
            <a:ext cx="0" cy="165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5"/>
          <p:cNvSpPr/>
          <p:nvPr/>
        </p:nvSpPr>
        <p:spPr>
          <a:xfrm rot="16200000">
            <a:off x="-375480" y="2050920"/>
            <a:ext cx="107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Empty vect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7" descr="C:\Users\gn912\Desktop\Gabi FOXK2 localization\Gabi 2\Gabi FOXK2 localization\MCF7 6h 3.tif"/>
          <p:cNvPicPr/>
          <p:nvPr/>
        </p:nvPicPr>
        <p:blipFill>
          <a:blip r:embed="rId4"/>
          <a:stretch/>
        </p:blipFill>
        <p:spPr>
          <a:xfrm>
            <a:off x="2374920" y="2203560"/>
            <a:ext cx="963720" cy="96336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8" descr="C:\Users\gn912\Desktop\Gabi FOXK2 localization\Gabi 2\Gabi FOXK2 localization\MCF7 6h 3_ch00.tif"/>
          <p:cNvPicPr/>
          <p:nvPr/>
        </p:nvPicPr>
        <p:blipFill>
          <a:blip r:embed="rId5"/>
          <a:stretch/>
        </p:blipFill>
        <p:spPr>
          <a:xfrm>
            <a:off x="1353960" y="2224080"/>
            <a:ext cx="971640" cy="95256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9" descr="C:\Users\gn912\Desktop\Gabi FOXK2 localization\Gabi 2\Gabi FOXK2 localization\MCF7 6h 3_ch01.tif"/>
          <p:cNvPicPr/>
          <p:nvPr/>
        </p:nvPicPr>
        <p:blipFill>
          <a:blip r:embed="rId6"/>
          <a:stretch/>
        </p:blipFill>
        <p:spPr>
          <a:xfrm>
            <a:off x="353880" y="2224080"/>
            <a:ext cx="963720" cy="96984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0" descr="C:\Users\gn912\Desktop\Gabi FOXK2 localization\Gabi 2\Gabi FOXK2 localization\MCF7 WT 6h 1.tif"/>
          <p:cNvPicPr/>
          <p:nvPr/>
        </p:nvPicPr>
        <p:blipFill>
          <a:blip r:embed="rId7"/>
          <a:stretch/>
        </p:blipFill>
        <p:spPr>
          <a:xfrm>
            <a:off x="2347920" y="3303720"/>
            <a:ext cx="973080" cy="9730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11" descr="C:\Users\gn912\Desktop\Gabi FOXK2 localization\Gabi 2\Gabi FOXK2 localization\MCF7 WT 6h 1_ch00.tif"/>
          <p:cNvPicPr/>
          <p:nvPr/>
        </p:nvPicPr>
        <p:blipFill>
          <a:blip r:embed="rId8"/>
          <a:stretch/>
        </p:blipFill>
        <p:spPr>
          <a:xfrm>
            <a:off x="1352520" y="3303720"/>
            <a:ext cx="973080" cy="97308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12" descr="C:\Users\gn912\Desktop\Gabi FOXK2 localization\Gabi 2\Gabi FOXK2 localization\MCF7 WT 6h 1_ch01.tif"/>
          <p:cNvPicPr/>
          <p:nvPr/>
        </p:nvPicPr>
        <p:blipFill>
          <a:blip r:embed="rId9"/>
          <a:stretch/>
        </p:blipFill>
        <p:spPr>
          <a:xfrm>
            <a:off x="365040" y="3324240"/>
            <a:ext cx="952560" cy="952560"/>
          </a:xfrm>
          <a:prstGeom prst="rect">
            <a:avLst/>
          </a:prstGeom>
          <a:ln w="0">
            <a:noFill/>
          </a:ln>
        </p:spPr>
      </p:pic>
      <p:sp>
        <p:nvSpPr>
          <p:cNvPr id="62" name="Straight Connector 19"/>
          <p:cNvSpPr/>
          <p:nvPr/>
        </p:nvSpPr>
        <p:spPr>
          <a:xfrm>
            <a:off x="299880" y="3519360"/>
            <a:ext cx="0" cy="1657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4"/>
          <p:cNvSpPr/>
          <p:nvPr/>
        </p:nvSpPr>
        <p:spPr>
          <a:xfrm rot="16200000">
            <a:off x="-518040" y="4139280"/>
            <a:ext cx="136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Wild-type 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Picture 13" descr="C:\Users\gn912\Desktop\Gabi FOXK2 localization\Gabi 2\Gabi FOXK2 localization\MCF7 WT 6h 3.tif"/>
          <p:cNvPicPr/>
          <p:nvPr/>
        </p:nvPicPr>
        <p:blipFill>
          <a:blip r:embed="rId10"/>
          <a:stretch/>
        </p:blipFill>
        <p:spPr>
          <a:xfrm>
            <a:off x="2355840" y="4311720"/>
            <a:ext cx="965160" cy="9666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4" descr="C:\Users\gn912\Desktop\Gabi FOXK2 localization\Gabi 2\Gabi FOXK2 localization\MCF7 WT 6h 3_ch00.tif"/>
          <p:cNvPicPr/>
          <p:nvPr/>
        </p:nvPicPr>
        <p:blipFill>
          <a:blip r:embed="rId11"/>
          <a:stretch/>
        </p:blipFill>
        <p:spPr>
          <a:xfrm>
            <a:off x="1359000" y="4311720"/>
            <a:ext cx="966600" cy="96840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5" descr="C:\Users\gn912\Desktop\Gabi FOXK2 localization\Gabi 2\Gabi FOXK2 localization\MCF7 WT 6h 3_ch01.tif"/>
          <p:cNvPicPr/>
          <p:nvPr/>
        </p:nvPicPr>
        <p:blipFill>
          <a:blip r:embed="rId12"/>
          <a:stretch/>
        </p:blipFill>
        <p:spPr>
          <a:xfrm>
            <a:off x="380880" y="4311720"/>
            <a:ext cx="963720" cy="968400"/>
          </a:xfrm>
          <a:prstGeom prst="rect">
            <a:avLst/>
          </a:prstGeom>
          <a:ln w="0">
            <a:noFill/>
          </a:ln>
        </p:spPr>
      </p:pic>
      <p:sp>
        <p:nvSpPr>
          <p:cNvPr id="67" name="TextBox 3"/>
          <p:cNvSpPr/>
          <p:nvPr/>
        </p:nvSpPr>
        <p:spPr>
          <a:xfrm>
            <a:off x="5016240" y="94788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ff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8"/>
          <p:cNvSpPr/>
          <p:nvPr/>
        </p:nvSpPr>
        <p:spPr>
          <a:xfrm>
            <a:off x="5879880" y="947880"/>
            <a:ext cx="63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Picture 2" descr="C:\Users\gn912\Desktop\Gabi FOXK2 localization\Gabi 2\Gabi FOXK2 localization\TaxR WT 0h 1.tif"/>
          <p:cNvPicPr/>
          <p:nvPr/>
        </p:nvPicPr>
        <p:blipFill>
          <a:blip r:embed="rId13"/>
          <a:stretch/>
        </p:blipFill>
        <p:spPr>
          <a:xfrm>
            <a:off x="5781600" y="3287880"/>
            <a:ext cx="957240" cy="9554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3" descr="C:\Users\gn912\Desktop\Gabi FOXK2 localization\Gabi 2\Gabi FOXK2 localization\TaxR WT 0h 1_ch00.tif"/>
          <p:cNvPicPr/>
          <p:nvPr/>
        </p:nvPicPr>
        <p:blipFill>
          <a:blip r:embed="rId14"/>
          <a:stretch/>
        </p:blipFill>
        <p:spPr>
          <a:xfrm>
            <a:off x="4761000" y="3287880"/>
            <a:ext cx="971640" cy="96012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4" descr="C:\Users\gn912\Desktop\Gabi FOXK2 localization\Gabi 2\Gabi FOXK2 localization\TaxR WT 0h 1_ch01.tif"/>
          <p:cNvPicPr/>
          <p:nvPr/>
        </p:nvPicPr>
        <p:blipFill>
          <a:blip r:embed="rId15"/>
          <a:stretch/>
        </p:blipFill>
        <p:spPr>
          <a:xfrm>
            <a:off x="3757680" y="3287880"/>
            <a:ext cx="971640" cy="95544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5" descr="C:\Users\gn912\Desktop\Gabi FOXK2 localization\Gabi 2\Gabi FOXK2 localization\TaxR WT 6h 1_ch01.tif"/>
          <p:cNvPicPr/>
          <p:nvPr/>
        </p:nvPicPr>
        <p:blipFill>
          <a:blip r:embed="rId16"/>
          <a:stretch/>
        </p:blipFill>
        <p:spPr>
          <a:xfrm>
            <a:off x="4761000" y="4276800"/>
            <a:ext cx="971640" cy="95076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6" descr="C:\Users\gn912\Desktop\Gabi FOXK2 localization\Gabi 2\Gabi FOXK2 localization\TaxR WT 6h 1.tif"/>
          <p:cNvPicPr/>
          <p:nvPr/>
        </p:nvPicPr>
        <p:blipFill>
          <a:blip r:embed="rId17"/>
          <a:stretch/>
        </p:blipFill>
        <p:spPr>
          <a:xfrm>
            <a:off x="5781600" y="4270320"/>
            <a:ext cx="957240" cy="95724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7" descr="C:\Users\gn912\Desktop\Gabi FOXK2 localization\Gabi 2\Gabi FOXK2 localization\TaxR WT 6h 1_ch00.tif"/>
          <p:cNvPicPr/>
          <p:nvPr/>
        </p:nvPicPr>
        <p:blipFill>
          <a:blip r:embed="rId18"/>
          <a:stretch/>
        </p:blipFill>
        <p:spPr>
          <a:xfrm>
            <a:off x="4761000" y="4276800"/>
            <a:ext cx="971640" cy="95076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8" descr="C:\Users\gn912\Desktop\Gabi FOXK2 localization\Gabi 2\Gabi FOXK2 localization\TaxR WT 6h 1_ch01.tif"/>
          <p:cNvPicPr/>
          <p:nvPr/>
        </p:nvPicPr>
        <p:blipFill>
          <a:blip r:embed="rId19"/>
          <a:stretch/>
        </p:blipFill>
        <p:spPr>
          <a:xfrm>
            <a:off x="3757680" y="4268880"/>
            <a:ext cx="961920" cy="95868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9" descr="C:\Users\gn912\Desktop\Gabi FOXK2 localization\Gabi 2\Gabi FOXK2 localization\TaxR EV 0h 2.tif"/>
          <p:cNvPicPr/>
          <p:nvPr/>
        </p:nvPicPr>
        <p:blipFill>
          <a:blip r:embed="rId20"/>
          <a:stretch/>
        </p:blipFill>
        <p:spPr>
          <a:xfrm>
            <a:off x="5765760" y="1198440"/>
            <a:ext cx="971640" cy="95724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10" descr="C:\Users\gn912\Desktop\Gabi FOXK2 localization\Gabi 2\Gabi FOXK2 localization\TaxR EV 0h 2_ch00.tif"/>
          <p:cNvPicPr/>
          <p:nvPr/>
        </p:nvPicPr>
        <p:blipFill>
          <a:blip r:embed="rId21"/>
          <a:stretch/>
        </p:blipFill>
        <p:spPr>
          <a:xfrm>
            <a:off x="4761000" y="1208160"/>
            <a:ext cx="971640" cy="95256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11" descr="C:\Users\gn912\Desktop\Gabi FOXK2 localization\Gabi 2\Gabi FOXK2 localization\TaxR EV 0h 2_ch01.tif"/>
          <p:cNvPicPr/>
          <p:nvPr/>
        </p:nvPicPr>
        <p:blipFill>
          <a:blip r:embed="rId22"/>
          <a:stretch/>
        </p:blipFill>
        <p:spPr>
          <a:xfrm>
            <a:off x="3757680" y="1208160"/>
            <a:ext cx="957240" cy="95544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12" descr="C:\Users\gn912\Desktop\Gabi FOXK2 localization\Gabi 2\Gabi FOXK2 localization\TaxR EV 6h 3.tif"/>
          <p:cNvPicPr/>
          <p:nvPr/>
        </p:nvPicPr>
        <p:blipFill>
          <a:blip r:embed="rId23"/>
          <a:stretch/>
        </p:blipFill>
        <p:spPr>
          <a:xfrm>
            <a:off x="5765760" y="2195640"/>
            <a:ext cx="971640" cy="97128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13" descr="C:\Users\gn912\Desktop\Gabi FOXK2 localization\Gabi 2\Gabi FOXK2 localization\TaxR EV 6h 3_ch00.tif"/>
          <p:cNvPicPr/>
          <p:nvPr/>
        </p:nvPicPr>
        <p:blipFill>
          <a:blip r:embed="rId24"/>
          <a:stretch/>
        </p:blipFill>
        <p:spPr>
          <a:xfrm>
            <a:off x="4761000" y="2195640"/>
            <a:ext cx="971640" cy="97128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14" descr="C:\Users\gn912\Desktop\Gabi FOXK2 localization\Gabi 2\Gabi FOXK2 localization\TaxR EV 6h 3_ch01.tif"/>
          <p:cNvPicPr/>
          <p:nvPr/>
        </p:nvPicPr>
        <p:blipFill>
          <a:blip r:embed="rId25"/>
          <a:stretch/>
        </p:blipFill>
        <p:spPr>
          <a:xfrm>
            <a:off x="3757680" y="2195640"/>
            <a:ext cx="961920" cy="971280"/>
          </a:xfrm>
          <a:prstGeom prst="rect">
            <a:avLst/>
          </a:prstGeom>
          <a:ln w="0">
            <a:noFill/>
          </a:ln>
        </p:spPr>
      </p:pic>
      <p:sp>
        <p:nvSpPr>
          <p:cNvPr id="82" name="TextBox 59"/>
          <p:cNvSpPr/>
          <p:nvPr/>
        </p:nvSpPr>
        <p:spPr>
          <a:xfrm>
            <a:off x="3863520" y="981000"/>
            <a:ext cx="68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e668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CaixaDeTexto 10"/>
          <p:cNvSpPr/>
          <p:nvPr/>
        </p:nvSpPr>
        <p:spPr>
          <a:xfrm>
            <a:off x="1376280" y="62244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CaixaDeTexto 11"/>
          <p:cNvSpPr/>
          <p:nvPr/>
        </p:nvSpPr>
        <p:spPr>
          <a:xfrm>
            <a:off x="4581360" y="622440"/>
            <a:ext cx="133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Tax</a:t>
            </a:r>
            <a:r>
              <a:rPr b="0" lang="pt-BR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4"/>
          <p:cNvSpPr/>
          <p:nvPr/>
        </p:nvSpPr>
        <p:spPr>
          <a:xfrm>
            <a:off x="3322440" y="153972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0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19"/>
          <p:cNvSpPr/>
          <p:nvPr/>
        </p:nvSpPr>
        <p:spPr>
          <a:xfrm>
            <a:off x="3322440" y="254808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28"/>
          <p:cNvSpPr/>
          <p:nvPr/>
        </p:nvSpPr>
        <p:spPr>
          <a:xfrm>
            <a:off x="3322440" y="363852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0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29"/>
          <p:cNvSpPr/>
          <p:nvPr/>
        </p:nvSpPr>
        <p:spPr>
          <a:xfrm>
            <a:off x="3322440" y="456732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6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8"/>
          <p:cNvSpPr/>
          <p:nvPr/>
        </p:nvSpPr>
        <p:spPr>
          <a:xfrm>
            <a:off x="3083040" y="5280120"/>
            <a:ext cx="877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clitaxel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nM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43"/>
          <p:cNvSpPr/>
          <p:nvPr/>
        </p:nvSpPr>
        <p:spPr>
          <a:xfrm>
            <a:off x="4933440" y="879300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2:36:50Z</dcterms:modified>
  <cp:revision>202</cp:revision>
  <dc:subject/>
  <dc:title>PowerPoint Presentation</dc:title>
</cp:coreProperties>
</file>